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1566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D8858-303D-47A3-BF81-34A215C3AB11}" type="datetimeFigureOut">
              <a:rPr lang="en-US" smtClean="0"/>
              <a:pPr/>
              <a:t>12/2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3D982-4011-4A4B-A10B-38067EB9A3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D8858-303D-47A3-BF81-34A215C3AB11}" type="datetimeFigureOut">
              <a:rPr lang="en-US" smtClean="0"/>
              <a:pPr/>
              <a:t>12/2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3D982-4011-4A4B-A10B-38067EB9A3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D8858-303D-47A3-BF81-34A215C3AB11}" type="datetimeFigureOut">
              <a:rPr lang="en-US" smtClean="0"/>
              <a:pPr/>
              <a:t>12/2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3D982-4011-4A4B-A10B-38067EB9A3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D8858-303D-47A3-BF81-34A215C3AB11}" type="datetimeFigureOut">
              <a:rPr lang="en-US" smtClean="0"/>
              <a:pPr/>
              <a:t>12/2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3D982-4011-4A4B-A10B-38067EB9A3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D8858-303D-47A3-BF81-34A215C3AB11}" type="datetimeFigureOut">
              <a:rPr lang="en-US" smtClean="0"/>
              <a:pPr/>
              <a:t>12/2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3D982-4011-4A4B-A10B-38067EB9A3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D8858-303D-47A3-BF81-34A215C3AB11}" type="datetimeFigureOut">
              <a:rPr lang="en-US" smtClean="0"/>
              <a:pPr/>
              <a:t>12/2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3D982-4011-4A4B-A10B-38067EB9A3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D8858-303D-47A3-BF81-34A215C3AB11}" type="datetimeFigureOut">
              <a:rPr lang="en-US" smtClean="0"/>
              <a:pPr/>
              <a:t>12/2/20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3D982-4011-4A4B-A10B-38067EB9A3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D8858-303D-47A3-BF81-34A215C3AB11}" type="datetimeFigureOut">
              <a:rPr lang="en-US" smtClean="0"/>
              <a:pPr/>
              <a:t>12/2/20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3D982-4011-4A4B-A10B-38067EB9A3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D8858-303D-47A3-BF81-34A215C3AB11}" type="datetimeFigureOut">
              <a:rPr lang="en-US" smtClean="0"/>
              <a:pPr/>
              <a:t>12/2/20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3D982-4011-4A4B-A10B-38067EB9A3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D8858-303D-47A3-BF81-34A215C3AB11}" type="datetimeFigureOut">
              <a:rPr lang="en-US" smtClean="0"/>
              <a:pPr/>
              <a:t>12/2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3D982-4011-4A4B-A10B-38067EB9A3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D8858-303D-47A3-BF81-34A215C3AB11}" type="datetimeFigureOut">
              <a:rPr lang="en-US" smtClean="0"/>
              <a:pPr/>
              <a:t>12/2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C3D982-4011-4A4B-A10B-38067EB9A3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D8858-303D-47A3-BF81-34A215C3AB11}" type="datetimeFigureOut">
              <a:rPr lang="en-US" smtClean="0"/>
              <a:pPr/>
              <a:t>12/2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C3D982-4011-4A4B-A10B-38067EB9A3E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re 1"/>
          <p:cNvSpPr txBox="1">
            <a:spLocks/>
          </p:cNvSpPr>
          <p:nvPr/>
        </p:nvSpPr>
        <p:spPr>
          <a:xfrm>
            <a:off x="152400" y="76200"/>
            <a:ext cx="8763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2400" b="1" dirty="0">
                <a:solidFill>
                  <a:srgbClr val="FF0000"/>
                </a:solidFill>
                <a:latin typeface="Century Gothic" pitchFamily="34" charset="0"/>
                <a:ea typeface="+mj-ea"/>
                <a:cs typeface="+mj-cs"/>
              </a:rPr>
              <a:t>Distribution of MIRU-VNTR molecular markers in MU-positive and negative animal lesions </a:t>
            </a:r>
            <a:endParaRPr kumimoji="0" lang="en-US" sz="24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entury Gothic" pitchFamily="34" charset="0"/>
              <a:ea typeface="+mj-ea"/>
              <a:cs typeface="+mj-cs"/>
            </a:endParaRPr>
          </a:p>
        </p:txBody>
      </p:sp>
      <p:graphicFrame>
        <p:nvGraphicFramePr>
          <p:cNvPr id="5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3962403"/>
              </p:ext>
            </p:extLst>
          </p:nvPr>
        </p:nvGraphicFramePr>
        <p:xfrm>
          <a:off x="533400" y="1219200"/>
          <a:ext cx="8153402" cy="511990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5005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500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4308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775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1768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7945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9228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4308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76117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914402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350097">
                <a:tc rowSpan="2"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Samples code</a:t>
                      </a: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MU status </a:t>
                      </a: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MIRU1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Locus 6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VNTR-19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ST-1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MU genotyp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54613">
                <a:tc vMerge="1">
                  <a:txBody>
                    <a:bodyPr/>
                    <a:lstStyle/>
                    <a:p>
                      <a:endParaRPr lang="en-US" sz="16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B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aseline="0" dirty="0">
                          <a:latin typeface="Century Gothic" pitchFamily="34" charset="0"/>
                        </a:rPr>
                        <a:t>Copy  N</a:t>
                      </a:r>
                      <a:r>
                        <a:rPr lang="en-US" sz="1100" baseline="30000" dirty="0">
                          <a:latin typeface="Century Gothic" pitchFamily="34" charset="0"/>
                        </a:rPr>
                        <a:t>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B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aseline="0" dirty="0">
                          <a:latin typeface="Century Gothic" pitchFamily="34" charset="0"/>
                        </a:rPr>
                        <a:t>Copy  N</a:t>
                      </a:r>
                      <a:r>
                        <a:rPr lang="en-US" sz="1100" baseline="30000" dirty="0">
                          <a:latin typeface="Century Gothic" pitchFamily="34" charset="0"/>
                        </a:rPr>
                        <a:t>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B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aseline="0" dirty="0">
                          <a:latin typeface="Century Gothic" pitchFamily="34" charset="0"/>
                        </a:rPr>
                        <a:t>Copy  N</a:t>
                      </a:r>
                      <a:r>
                        <a:rPr lang="en-US" sz="1100" baseline="30000" dirty="0">
                          <a:latin typeface="Century Gothic" pitchFamily="34" charset="0"/>
                        </a:rPr>
                        <a:t>o</a:t>
                      </a:r>
                    </a:p>
                    <a:p>
                      <a:pPr algn="ctr"/>
                      <a:endParaRPr lang="en-US" sz="1100" dirty="0">
                        <a:latin typeface="Century Gothic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B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aseline="0" dirty="0">
                          <a:latin typeface="Century Gothic" pitchFamily="34" charset="0"/>
                        </a:rPr>
                        <a:t>Copy  N</a:t>
                      </a:r>
                      <a:r>
                        <a:rPr lang="en-US" sz="1100" baseline="30000" dirty="0">
                          <a:latin typeface="Century Gothic" pitchFamily="34" charset="0"/>
                        </a:rPr>
                        <a:t>o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50097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AD01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Posi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48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5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4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C-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50097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AD02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Nega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2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3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50097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AD04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Nega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2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5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2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3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50097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AD05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Nega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3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3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50097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AD10Sw</a:t>
                      </a:r>
                    </a:p>
                  </a:txBody>
                  <a:tcP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Negative</a:t>
                      </a:r>
                    </a:p>
                  </a:txBody>
                  <a:tcP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200</a:t>
                      </a:r>
                    </a:p>
                  </a:txBody>
                  <a:tcP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UA</a:t>
                      </a:r>
                    </a:p>
                  </a:txBody>
                  <a:tcP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400</a:t>
                      </a:r>
                    </a:p>
                  </a:txBody>
                  <a:tcP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0</a:t>
                      </a:r>
                    </a:p>
                  </a:txBody>
                  <a:tcP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700</a:t>
                      </a:r>
                    </a:p>
                  </a:txBody>
                  <a:tcP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UA</a:t>
                      </a:r>
                    </a:p>
                  </a:txBody>
                  <a:tcP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UA</a:t>
                      </a:r>
                    </a:p>
                  </a:txBody>
                  <a:tcP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50097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AD21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Nega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3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2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Century Gothic" pitchFamily="34" charset="0"/>
                        </a:rPr>
                        <a:t>U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50097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AD80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Posi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5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5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3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4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Z (BK04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50097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AD81Sw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Posi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5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5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3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4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Century Gothic" pitchFamily="34" charset="0"/>
                        </a:rPr>
                        <a:t>Z (BK04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612671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Positive</a:t>
                      </a:r>
                      <a:r>
                        <a:rPr lang="en-US" sz="1100" b="1" baseline="0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 control (MU Agy99)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Century Gothic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Posi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48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5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3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4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C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711043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Negative</a:t>
                      </a:r>
                      <a:r>
                        <a:rPr lang="en-US" sz="1100" b="1" baseline="0" dirty="0">
                          <a:solidFill>
                            <a:schemeClr val="tx1"/>
                          </a:solidFill>
                          <a:latin typeface="Century Gothic" pitchFamily="34" charset="0"/>
                        </a:rPr>
                        <a:t> control (Water)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Century Gothic" pitchFamily="34" charset="0"/>
                      </a:endParaRPr>
                    </a:p>
                    <a:p>
                      <a:pPr algn="ctr"/>
                      <a:endParaRPr lang="en-US" sz="1100" b="1" dirty="0">
                        <a:solidFill>
                          <a:schemeClr val="tx1"/>
                        </a:solidFill>
                        <a:latin typeface="Century Gothic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Negati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U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1100" kern="1200" dirty="0">
                          <a:solidFill>
                            <a:schemeClr val="dk1"/>
                          </a:solidFill>
                          <a:latin typeface="Century Gothic" pitchFamily="34" charset="0"/>
                          <a:ea typeface="+mn-ea"/>
                          <a:cs typeface="+mn-cs"/>
                        </a:rPr>
                        <a:t>U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5</TotalTime>
  <Words>159</Words>
  <Application>Microsoft Office PowerPoint</Application>
  <PresentationFormat>On-screen Show (4:3)</PresentationFormat>
  <Paragraphs>1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entury Gothic</vt:lpstr>
      <vt:lpstr>Thèm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ZEUS</dc:creator>
  <cp:lastModifiedBy>Francis Zeukeng</cp:lastModifiedBy>
  <cp:revision>13</cp:revision>
  <dcterms:created xsi:type="dcterms:W3CDTF">2017-05-02T14:58:42Z</dcterms:created>
  <dcterms:modified xsi:type="dcterms:W3CDTF">2017-12-02T22:02:05Z</dcterms:modified>
</cp:coreProperties>
</file>